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1560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E1513-1C04-4C32-8799-65BAB69E363A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548E9-3A4F-4382-9D45-C730225FBA2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26118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E1513-1C04-4C32-8799-65BAB69E363A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548E9-3A4F-4382-9D45-C730225FBA2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72876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E1513-1C04-4C32-8799-65BAB69E363A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548E9-3A4F-4382-9D45-C730225FBA2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71164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E1513-1C04-4C32-8799-65BAB69E363A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548E9-3A4F-4382-9D45-C730225FBA2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398713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E1513-1C04-4C32-8799-65BAB69E363A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548E9-3A4F-4382-9D45-C730225FBA2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23692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E1513-1C04-4C32-8799-65BAB69E363A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548E9-3A4F-4382-9D45-C730225FBA2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8142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E1513-1C04-4C32-8799-65BAB69E363A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548E9-3A4F-4382-9D45-C730225FBA2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5529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E1513-1C04-4C32-8799-65BAB69E363A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548E9-3A4F-4382-9D45-C730225FBA2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9764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E1513-1C04-4C32-8799-65BAB69E363A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548E9-3A4F-4382-9D45-C730225FBA2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12167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E1513-1C04-4C32-8799-65BAB69E363A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548E9-3A4F-4382-9D45-C730225FBA2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83406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E1513-1C04-4C32-8799-65BAB69E363A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548E9-3A4F-4382-9D45-C730225FBA2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58638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BE1513-1C04-4C32-8799-65BAB69E363A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F548E9-3A4F-4382-9D45-C730225FBA2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648622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feld 23"/>
          <p:cNvSpPr txBox="1"/>
          <p:nvPr/>
        </p:nvSpPr>
        <p:spPr>
          <a:xfrm>
            <a:off x="151636" y="90100"/>
            <a:ext cx="6249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latin typeface="Arial" pitchFamily="34" charset="0"/>
                <a:cs typeface="Arial" pitchFamily="34" charset="0"/>
              </a:rPr>
              <a:t>Additional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data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file</a:t>
            </a:r>
            <a:r>
              <a:rPr lang="de-DE" sz="1200" b="1" smtClean="0">
                <a:latin typeface="Arial" pitchFamily="34" charset="0"/>
                <a:cs typeface="Arial" pitchFamily="34" charset="0"/>
              </a:rPr>
              <a:t> 8: 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DNA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methylation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of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different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risk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groups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of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MDS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patients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5" name="Gruppieren 14"/>
          <p:cNvGrpSpPr/>
          <p:nvPr/>
        </p:nvGrpSpPr>
        <p:grpSpPr>
          <a:xfrm>
            <a:off x="-103363" y="381000"/>
            <a:ext cx="6430766" cy="6224891"/>
            <a:chOff x="-103363" y="381000"/>
            <a:chExt cx="6430766" cy="6224891"/>
          </a:xfrm>
        </p:grpSpPr>
        <p:pic>
          <p:nvPicPr>
            <p:cNvPr id="109" name="Picture 11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7011"/>
            <a:stretch/>
          </p:blipFill>
          <p:spPr bwMode="auto">
            <a:xfrm>
              <a:off x="2923299" y="5563316"/>
              <a:ext cx="2182101" cy="10425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2" name="Picture 8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1278"/>
            <a:stretch/>
          </p:blipFill>
          <p:spPr bwMode="auto">
            <a:xfrm>
              <a:off x="92146" y="4191000"/>
              <a:ext cx="2639174" cy="13365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" name="Textfeld 4"/>
            <p:cNvSpPr txBox="1"/>
            <p:nvPr/>
          </p:nvSpPr>
          <p:spPr>
            <a:xfrm>
              <a:off x="496825" y="685800"/>
              <a:ext cx="1447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i="1" dirty="0" smtClean="0">
                  <a:latin typeface="Arial" pitchFamily="34" charset="0"/>
                  <a:cs typeface="Arial" pitchFamily="34" charset="0"/>
                </a:rPr>
                <a:t>FZD5</a:t>
              </a:r>
              <a:endParaRPr lang="de-DE" sz="1200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380237" y="381000"/>
              <a:ext cx="1447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de-DE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496825" y="3947770"/>
              <a:ext cx="1447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i="1" dirty="0" smtClean="0">
                  <a:latin typeface="Arial" pitchFamily="34" charset="0"/>
                  <a:cs typeface="Arial" pitchFamily="34" charset="0"/>
                </a:rPr>
                <a:t>FZD8</a:t>
              </a:r>
              <a:endParaRPr lang="de-DE" sz="1200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380237" y="3670771"/>
              <a:ext cx="1447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de-DE" sz="12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" name="Gerade Verbindung 6"/>
            <p:cNvCxnSpPr/>
            <p:nvPr/>
          </p:nvCxnSpPr>
          <p:spPr>
            <a:xfrm>
              <a:off x="1217675" y="4572000"/>
              <a:ext cx="0" cy="76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Gerade Verbindung 16"/>
            <p:cNvCxnSpPr/>
            <p:nvPr/>
          </p:nvCxnSpPr>
          <p:spPr>
            <a:xfrm>
              <a:off x="2438400" y="4572000"/>
              <a:ext cx="0" cy="76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Gerade Verbindung 8"/>
            <p:cNvCxnSpPr/>
            <p:nvPr/>
          </p:nvCxnSpPr>
          <p:spPr>
            <a:xfrm>
              <a:off x="1217675" y="4572000"/>
              <a:ext cx="122072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feld 9"/>
            <p:cNvSpPr txBox="1"/>
            <p:nvPr/>
          </p:nvSpPr>
          <p:spPr>
            <a:xfrm>
              <a:off x="1717018" y="4408535"/>
              <a:ext cx="3696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de-DE" sz="11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33" name="Picture 9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7328"/>
            <a:stretch/>
          </p:blipFill>
          <p:spPr bwMode="auto">
            <a:xfrm>
              <a:off x="2923299" y="4183685"/>
              <a:ext cx="2164427" cy="13438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25" name="Gerade Verbindung 24"/>
            <p:cNvCxnSpPr/>
            <p:nvPr/>
          </p:nvCxnSpPr>
          <p:spPr>
            <a:xfrm>
              <a:off x="3532935" y="4651950"/>
              <a:ext cx="0" cy="76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Gerade Verbindung 25"/>
            <p:cNvCxnSpPr/>
            <p:nvPr/>
          </p:nvCxnSpPr>
          <p:spPr>
            <a:xfrm>
              <a:off x="4876800" y="4651950"/>
              <a:ext cx="0" cy="76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Gerade Verbindung 26"/>
            <p:cNvCxnSpPr/>
            <p:nvPr/>
          </p:nvCxnSpPr>
          <p:spPr>
            <a:xfrm flipV="1">
              <a:off x="3532935" y="4648200"/>
              <a:ext cx="1343865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feld 27"/>
            <p:cNvSpPr txBox="1"/>
            <p:nvPr/>
          </p:nvSpPr>
          <p:spPr>
            <a:xfrm>
              <a:off x="4032278" y="4495800"/>
              <a:ext cx="3696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de-DE" sz="11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1" name="Gerade Verbindung 30"/>
            <p:cNvCxnSpPr/>
            <p:nvPr/>
          </p:nvCxnSpPr>
          <p:spPr>
            <a:xfrm>
              <a:off x="3884675" y="4430665"/>
              <a:ext cx="0" cy="76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Gerade Verbindung 31"/>
            <p:cNvCxnSpPr/>
            <p:nvPr/>
          </p:nvCxnSpPr>
          <p:spPr>
            <a:xfrm>
              <a:off x="4876800" y="4430665"/>
              <a:ext cx="0" cy="76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Gerade Verbindung 32"/>
            <p:cNvCxnSpPr/>
            <p:nvPr/>
          </p:nvCxnSpPr>
          <p:spPr>
            <a:xfrm>
              <a:off x="3884675" y="4430665"/>
              <a:ext cx="99212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feld 33"/>
            <p:cNvSpPr txBox="1"/>
            <p:nvPr/>
          </p:nvSpPr>
          <p:spPr>
            <a:xfrm>
              <a:off x="4262935" y="4267200"/>
              <a:ext cx="3696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de-DE" sz="11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34" name="Picture 10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6431"/>
            <a:stretch/>
          </p:blipFill>
          <p:spPr bwMode="auto">
            <a:xfrm>
              <a:off x="225537" y="990600"/>
              <a:ext cx="2520531" cy="134708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37" name="Gerade Verbindung 36"/>
            <p:cNvCxnSpPr/>
            <p:nvPr/>
          </p:nvCxnSpPr>
          <p:spPr>
            <a:xfrm>
              <a:off x="1219200" y="1077865"/>
              <a:ext cx="0" cy="76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Gerade Verbindung 37"/>
            <p:cNvCxnSpPr/>
            <p:nvPr/>
          </p:nvCxnSpPr>
          <p:spPr>
            <a:xfrm>
              <a:off x="2439925" y="1077865"/>
              <a:ext cx="0" cy="76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Gerade Verbindung 38"/>
            <p:cNvCxnSpPr/>
            <p:nvPr/>
          </p:nvCxnSpPr>
          <p:spPr>
            <a:xfrm>
              <a:off x="1219200" y="1077865"/>
              <a:ext cx="122072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feld 39"/>
            <p:cNvSpPr txBox="1"/>
            <p:nvPr/>
          </p:nvSpPr>
          <p:spPr>
            <a:xfrm>
              <a:off x="1674653" y="914400"/>
              <a:ext cx="3696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itchFamily="34" charset="0"/>
                  <a:cs typeface="Arial" pitchFamily="34" charset="0"/>
                </a:rPr>
                <a:t>**</a:t>
              </a:r>
              <a:endParaRPr lang="de-DE" sz="11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1" name="Gerade Verbindung 40"/>
            <p:cNvCxnSpPr/>
            <p:nvPr/>
          </p:nvCxnSpPr>
          <p:spPr>
            <a:xfrm>
              <a:off x="2050085" y="904671"/>
              <a:ext cx="0" cy="76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Gerade Verbindung 41"/>
            <p:cNvCxnSpPr/>
            <p:nvPr/>
          </p:nvCxnSpPr>
          <p:spPr>
            <a:xfrm>
              <a:off x="2438400" y="907085"/>
              <a:ext cx="0" cy="76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Gerade Verbindung 42"/>
            <p:cNvCxnSpPr/>
            <p:nvPr/>
          </p:nvCxnSpPr>
          <p:spPr>
            <a:xfrm>
              <a:off x="2048560" y="907085"/>
              <a:ext cx="38252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feld 43"/>
            <p:cNvSpPr txBox="1"/>
            <p:nvPr/>
          </p:nvSpPr>
          <p:spPr>
            <a:xfrm>
              <a:off x="2091124" y="743740"/>
              <a:ext cx="3696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itchFamily="34" charset="0"/>
                  <a:cs typeface="Arial" pitchFamily="34" charset="0"/>
                </a:rPr>
                <a:t>**</a:t>
              </a:r>
              <a:endParaRPr lang="de-DE" sz="11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35" name="Picture 11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23299" y="983285"/>
              <a:ext cx="2182101" cy="24252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48" name="Gerade Verbindung 47"/>
            <p:cNvCxnSpPr/>
            <p:nvPr/>
          </p:nvCxnSpPr>
          <p:spPr>
            <a:xfrm>
              <a:off x="3890465" y="1077865"/>
              <a:ext cx="0" cy="76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Gerade Verbindung 48"/>
            <p:cNvCxnSpPr/>
            <p:nvPr/>
          </p:nvCxnSpPr>
          <p:spPr>
            <a:xfrm>
              <a:off x="4882590" y="1077865"/>
              <a:ext cx="0" cy="76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Gerade Verbindung 49"/>
            <p:cNvCxnSpPr/>
            <p:nvPr/>
          </p:nvCxnSpPr>
          <p:spPr>
            <a:xfrm>
              <a:off x="3890465" y="1077865"/>
              <a:ext cx="99212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feld 50"/>
            <p:cNvSpPr txBox="1"/>
            <p:nvPr/>
          </p:nvSpPr>
          <p:spPr>
            <a:xfrm>
              <a:off x="4254095" y="914400"/>
              <a:ext cx="3696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itchFamily="34" charset="0"/>
                  <a:cs typeface="Arial" pitchFamily="34" charset="0"/>
                </a:rPr>
                <a:t>**</a:t>
              </a:r>
              <a:endParaRPr lang="de-DE" sz="11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2" name="Gerade Verbindung 51"/>
            <p:cNvCxnSpPr/>
            <p:nvPr/>
          </p:nvCxnSpPr>
          <p:spPr>
            <a:xfrm>
              <a:off x="4187340" y="914400"/>
              <a:ext cx="0" cy="76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Gerade Verbindung 52"/>
            <p:cNvCxnSpPr/>
            <p:nvPr/>
          </p:nvCxnSpPr>
          <p:spPr>
            <a:xfrm>
              <a:off x="4876800" y="916813"/>
              <a:ext cx="0" cy="76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Gerade Verbindung 53"/>
            <p:cNvCxnSpPr/>
            <p:nvPr/>
          </p:nvCxnSpPr>
          <p:spPr>
            <a:xfrm>
              <a:off x="4189475" y="914400"/>
              <a:ext cx="68732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feld 54"/>
            <p:cNvSpPr txBox="1"/>
            <p:nvPr/>
          </p:nvSpPr>
          <p:spPr>
            <a:xfrm>
              <a:off x="4421435" y="762000"/>
              <a:ext cx="36964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itchFamily="34" charset="0"/>
                  <a:cs typeface="Arial" pitchFamily="34" charset="0"/>
                </a:rPr>
                <a:t>**</a:t>
              </a:r>
              <a:endParaRPr lang="de-DE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Textfeld 63"/>
            <p:cNvSpPr txBox="1"/>
            <p:nvPr/>
          </p:nvSpPr>
          <p:spPr>
            <a:xfrm rot="18928083">
              <a:off x="3113455" y="1810692"/>
              <a:ext cx="2045009" cy="2046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30" dirty="0" smtClean="0">
                  <a:latin typeface="Arial" pitchFamily="34" charset="0"/>
                  <a:cs typeface="Arial" pitchFamily="34" charset="0"/>
                </a:rPr>
                <a:t>n=25</a:t>
              </a:r>
              <a:endParaRPr lang="de-DE" sz="73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Textfeld 64"/>
            <p:cNvSpPr txBox="1"/>
            <p:nvPr/>
          </p:nvSpPr>
          <p:spPr>
            <a:xfrm rot="18928083">
              <a:off x="3444194" y="1800566"/>
              <a:ext cx="2045009" cy="2046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30" dirty="0" smtClean="0">
                  <a:latin typeface="Arial" pitchFamily="34" charset="0"/>
                  <a:cs typeface="Arial" pitchFamily="34" charset="0"/>
                </a:rPr>
                <a:t>n=46</a:t>
              </a:r>
              <a:endParaRPr lang="de-DE" sz="73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" name="Textfeld 65"/>
            <p:cNvSpPr txBox="1"/>
            <p:nvPr/>
          </p:nvSpPr>
          <p:spPr>
            <a:xfrm rot="18928083">
              <a:off x="3780798" y="1797256"/>
              <a:ext cx="2045009" cy="2046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30" dirty="0" smtClean="0">
                  <a:latin typeface="Arial" pitchFamily="34" charset="0"/>
                  <a:cs typeface="Arial" pitchFamily="34" charset="0"/>
                </a:rPr>
                <a:t>n=20</a:t>
              </a:r>
              <a:endParaRPr lang="de-DE" sz="73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Textfeld 66"/>
            <p:cNvSpPr txBox="1"/>
            <p:nvPr/>
          </p:nvSpPr>
          <p:spPr>
            <a:xfrm rot="18928083">
              <a:off x="4106141" y="1808517"/>
              <a:ext cx="2045009" cy="2046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30" dirty="0" smtClean="0">
                  <a:latin typeface="Arial" pitchFamily="34" charset="0"/>
                  <a:cs typeface="Arial" pitchFamily="34" charset="0"/>
                </a:rPr>
                <a:t>n=9</a:t>
              </a:r>
              <a:endParaRPr lang="de-DE" sz="73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Textfeld 67"/>
            <p:cNvSpPr txBox="1"/>
            <p:nvPr/>
          </p:nvSpPr>
          <p:spPr>
            <a:xfrm rot="18928083">
              <a:off x="4282394" y="1984770"/>
              <a:ext cx="2045009" cy="2046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30" dirty="0" smtClean="0">
                  <a:latin typeface="Arial" pitchFamily="34" charset="0"/>
                  <a:cs typeface="Arial" pitchFamily="34" charset="0"/>
                </a:rPr>
                <a:t>n=8</a:t>
              </a:r>
              <a:endParaRPr lang="de-DE" sz="73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" name="Textfeld 72"/>
            <p:cNvSpPr txBox="1"/>
            <p:nvPr/>
          </p:nvSpPr>
          <p:spPr>
            <a:xfrm rot="18928083">
              <a:off x="3097554" y="5008916"/>
              <a:ext cx="2045009" cy="2046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30" dirty="0" smtClean="0">
                  <a:latin typeface="Arial" pitchFamily="34" charset="0"/>
                  <a:cs typeface="Arial" pitchFamily="34" charset="0"/>
                </a:rPr>
                <a:t>n=45</a:t>
              </a:r>
              <a:endParaRPr lang="de-DE" sz="73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" name="Textfeld 73"/>
            <p:cNvSpPr txBox="1"/>
            <p:nvPr/>
          </p:nvSpPr>
          <p:spPr>
            <a:xfrm rot="18928083">
              <a:off x="3435636" y="5003390"/>
              <a:ext cx="2045009" cy="2046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30" dirty="0" smtClean="0">
                  <a:latin typeface="Arial" pitchFamily="34" charset="0"/>
                  <a:cs typeface="Arial" pitchFamily="34" charset="0"/>
                </a:rPr>
                <a:t>n=63</a:t>
              </a:r>
              <a:endParaRPr lang="de-DE" sz="73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Textfeld 74"/>
            <p:cNvSpPr txBox="1"/>
            <p:nvPr/>
          </p:nvSpPr>
          <p:spPr>
            <a:xfrm rot="18928083">
              <a:off x="3775402" y="5011092"/>
              <a:ext cx="2045009" cy="2046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30" dirty="0" smtClean="0">
                  <a:latin typeface="Arial" pitchFamily="34" charset="0"/>
                  <a:cs typeface="Arial" pitchFamily="34" charset="0"/>
                </a:rPr>
                <a:t>n=25</a:t>
              </a:r>
              <a:endParaRPr lang="de-DE" sz="73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" name="Textfeld 75"/>
            <p:cNvSpPr txBox="1"/>
            <p:nvPr/>
          </p:nvSpPr>
          <p:spPr>
            <a:xfrm rot="18928083">
              <a:off x="4084843" y="5026994"/>
              <a:ext cx="2045009" cy="2046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30" dirty="0" smtClean="0">
                  <a:latin typeface="Arial" pitchFamily="34" charset="0"/>
                  <a:cs typeface="Arial" pitchFamily="34" charset="0"/>
                </a:rPr>
                <a:t>n=14</a:t>
              </a:r>
              <a:endParaRPr lang="de-DE" sz="73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Textfeld 76"/>
            <p:cNvSpPr txBox="1"/>
            <p:nvPr/>
          </p:nvSpPr>
          <p:spPr>
            <a:xfrm rot="18928083">
              <a:off x="4088899" y="5364775"/>
              <a:ext cx="2045009" cy="2046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30" dirty="0" smtClean="0">
                  <a:latin typeface="Arial" pitchFamily="34" charset="0"/>
                  <a:cs typeface="Arial" pitchFamily="34" charset="0"/>
                </a:rPr>
                <a:t>n=9</a:t>
              </a:r>
              <a:endParaRPr lang="de-DE" sz="73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" name="Gruppieren 5"/>
            <p:cNvGrpSpPr/>
            <p:nvPr/>
          </p:nvGrpSpPr>
          <p:grpSpPr>
            <a:xfrm>
              <a:off x="-92102" y="2097409"/>
              <a:ext cx="3621155" cy="994241"/>
              <a:chOff x="-92102" y="2097409"/>
              <a:chExt cx="3621155" cy="994241"/>
            </a:xfrm>
          </p:grpSpPr>
          <p:sp>
            <p:nvSpPr>
              <p:cNvPr id="83" name="Textfeld 82"/>
              <p:cNvSpPr txBox="1"/>
              <p:nvPr/>
            </p:nvSpPr>
            <p:spPr>
              <a:xfrm rot="18928083">
                <a:off x="1226950" y="2101796"/>
                <a:ext cx="2045009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730" dirty="0" smtClean="0">
                    <a:latin typeface="Arial" pitchFamily="34" charset="0"/>
                    <a:cs typeface="Arial" pitchFamily="34" charset="0"/>
                  </a:rPr>
                  <a:t>RAEB2, CMML2</a:t>
                </a:r>
                <a:endParaRPr lang="de-DE" sz="73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4" name="Gruppieren 3"/>
              <p:cNvGrpSpPr/>
              <p:nvPr/>
            </p:nvGrpSpPr>
            <p:grpSpPr>
              <a:xfrm>
                <a:off x="-92102" y="2097409"/>
                <a:ext cx="3621155" cy="994241"/>
                <a:chOff x="-92102" y="2097409"/>
                <a:chExt cx="3621155" cy="994241"/>
              </a:xfrm>
            </p:grpSpPr>
            <p:grpSp>
              <p:nvGrpSpPr>
                <p:cNvPr id="3" name="Gruppieren 2"/>
                <p:cNvGrpSpPr/>
                <p:nvPr/>
              </p:nvGrpSpPr>
              <p:grpSpPr>
                <a:xfrm>
                  <a:off x="-92102" y="2097409"/>
                  <a:ext cx="2911502" cy="994241"/>
                  <a:chOff x="-92102" y="2097409"/>
                  <a:chExt cx="2911502" cy="994241"/>
                </a:xfrm>
              </p:grpSpPr>
              <p:grpSp>
                <p:nvGrpSpPr>
                  <p:cNvPr id="2" name="Gruppieren 1"/>
                  <p:cNvGrpSpPr/>
                  <p:nvPr/>
                </p:nvGrpSpPr>
                <p:grpSpPr>
                  <a:xfrm>
                    <a:off x="-92102" y="2544711"/>
                    <a:ext cx="2045009" cy="546939"/>
                    <a:chOff x="1800994" y="3039587"/>
                    <a:chExt cx="2045009" cy="546939"/>
                  </a:xfrm>
                </p:grpSpPr>
                <p:sp>
                  <p:nvSpPr>
                    <p:cNvPr id="30" name="Textfeld 29"/>
                    <p:cNvSpPr txBox="1"/>
                    <p:nvPr/>
                  </p:nvSpPr>
                  <p:spPr>
                    <a:xfrm rot="18928083">
                      <a:off x="2259547" y="3381855"/>
                      <a:ext cx="679576" cy="20467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de-DE" sz="730" dirty="0" smtClean="0">
                          <a:latin typeface="Arial" pitchFamily="34" charset="0"/>
                          <a:cs typeface="Arial" pitchFamily="34" charset="0"/>
                        </a:rPr>
                        <a:t>n=59</a:t>
                      </a:r>
                      <a:endParaRPr lang="de-DE" sz="73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57" name="Textfeld 56"/>
                    <p:cNvSpPr txBox="1"/>
                    <p:nvPr/>
                  </p:nvSpPr>
                  <p:spPr>
                    <a:xfrm rot="18928083">
                      <a:off x="1800994" y="3039587"/>
                      <a:ext cx="2045009" cy="20774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de-DE" sz="730" dirty="0" smtClean="0">
                          <a:latin typeface="Arial" pitchFamily="34" charset="0"/>
                          <a:cs typeface="Arial" pitchFamily="34" charset="0"/>
                        </a:rPr>
                        <a:t>5q-, RA, RARS, RCMD, RSCMD</a:t>
                      </a:r>
                      <a:endParaRPr lang="de-DE" sz="73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grpSp>
                <p:nvGrpSpPr>
                  <p:cNvPr id="78" name="Gruppieren 77"/>
                  <p:cNvGrpSpPr/>
                  <p:nvPr/>
                </p:nvGrpSpPr>
                <p:grpSpPr>
                  <a:xfrm>
                    <a:off x="774391" y="2097409"/>
                    <a:ext cx="2045009" cy="554890"/>
                    <a:chOff x="1800994" y="3039587"/>
                    <a:chExt cx="2045009" cy="554890"/>
                  </a:xfrm>
                </p:grpSpPr>
                <p:sp>
                  <p:nvSpPr>
                    <p:cNvPr id="79" name="Textfeld 78"/>
                    <p:cNvSpPr txBox="1"/>
                    <p:nvPr/>
                  </p:nvSpPr>
                  <p:spPr>
                    <a:xfrm rot="18928083">
                      <a:off x="2259547" y="3389806"/>
                      <a:ext cx="679576" cy="20467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de-DE" sz="730" dirty="0" smtClean="0">
                          <a:latin typeface="Arial" pitchFamily="34" charset="0"/>
                          <a:cs typeface="Arial" pitchFamily="34" charset="0"/>
                        </a:rPr>
                        <a:t>n=17</a:t>
                      </a:r>
                      <a:endParaRPr lang="de-DE" sz="73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80" name="Textfeld 79"/>
                    <p:cNvSpPr txBox="1"/>
                    <p:nvPr/>
                  </p:nvSpPr>
                  <p:spPr>
                    <a:xfrm rot="18928083">
                      <a:off x="1800994" y="3039587"/>
                      <a:ext cx="2045009" cy="20774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de-DE" sz="730" dirty="0" smtClean="0">
                          <a:latin typeface="Arial" pitchFamily="34" charset="0"/>
                          <a:cs typeface="Arial" pitchFamily="34" charset="0"/>
                        </a:rPr>
                        <a:t>RAEB1, CMML1</a:t>
                      </a:r>
                      <a:endParaRPr lang="de-DE" sz="73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sp>
                <p:nvSpPr>
                  <p:cNvPr id="82" name="Textfeld 81"/>
                  <p:cNvSpPr txBox="1"/>
                  <p:nvPr/>
                </p:nvSpPr>
                <p:spPr>
                  <a:xfrm rot="18928083">
                    <a:off x="1685503" y="2443094"/>
                    <a:ext cx="679576" cy="20467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730" dirty="0" smtClean="0">
                        <a:latin typeface="Arial" pitchFamily="34" charset="0"/>
                        <a:cs typeface="Arial" pitchFamily="34" charset="0"/>
                      </a:rPr>
                      <a:t>n=24</a:t>
                    </a:r>
                    <a:endParaRPr lang="de-DE" sz="73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85" name="Textfeld 84"/>
                  <p:cNvSpPr txBox="1"/>
                  <p:nvPr/>
                </p:nvSpPr>
                <p:spPr>
                  <a:xfrm rot="18928083">
                    <a:off x="1942597" y="2591823"/>
                    <a:ext cx="679576" cy="20467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730" dirty="0" smtClean="0">
                        <a:latin typeface="Arial" pitchFamily="34" charset="0"/>
                        <a:cs typeface="Arial" pitchFamily="34" charset="0"/>
                      </a:rPr>
                      <a:t>n=8</a:t>
                    </a:r>
                    <a:endParaRPr lang="de-DE" sz="73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86" name="Textfeld 85"/>
                <p:cNvSpPr txBox="1"/>
                <p:nvPr/>
              </p:nvSpPr>
              <p:spPr>
                <a:xfrm rot="18928083">
                  <a:off x="1484044" y="2225702"/>
                  <a:ext cx="2045009" cy="20774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730" dirty="0" err="1" smtClean="0">
                      <a:latin typeface="Arial" pitchFamily="34" charset="0"/>
                      <a:cs typeface="Arial" pitchFamily="34" charset="0"/>
                    </a:rPr>
                    <a:t>Healthy</a:t>
                  </a:r>
                  <a:r>
                    <a:rPr lang="de-DE" sz="730" dirty="0" smtClean="0"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de-DE" sz="730" dirty="0" err="1" smtClean="0">
                      <a:latin typeface="Arial" pitchFamily="34" charset="0"/>
                      <a:cs typeface="Arial" pitchFamily="34" charset="0"/>
                    </a:rPr>
                    <a:t>Granulocytes</a:t>
                  </a:r>
                  <a:endParaRPr lang="de-DE" sz="73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  <p:grpSp>
          <p:nvGrpSpPr>
            <p:cNvPr id="8" name="Gruppieren 7"/>
            <p:cNvGrpSpPr/>
            <p:nvPr/>
          </p:nvGrpSpPr>
          <p:grpSpPr>
            <a:xfrm>
              <a:off x="-103363" y="5281653"/>
              <a:ext cx="3621155" cy="994241"/>
              <a:chOff x="-39755" y="5674995"/>
              <a:chExt cx="3621155" cy="994241"/>
            </a:xfrm>
          </p:grpSpPr>
          <p:sp>
            <p:nvSpPr>
              <p:cNvPr id="97" name="Textfeld 96"/>
              <p:cNvSpPr txBox="1"/>
              <p:nvPr/>
            </p:nvSpPr>
            <p:spPr>
              <a:xfrm rot="18928083">
                <a:off x="1279297" y="5679382"/>
                <a:ext cx="2045009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730" dirty="0" smtClean="0">
                    <a:latin typeface="Arial" pitchFamily="34" charset="0"/>
                    <a:cs typeface="Arial" pitchFamily="34" charset="0"/>
                  </a:rPr>
                  <a:t>RAEB2, CMML2</a:t>
                </a:r>
                <a:endParaRPr lang="de-DE" sz="73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" name="Textfeld 106"/>
              <p:cNvSpPr txBox="1"/>
              <p:nvPr/>
            </p:nvSpPr>
            <p:spPr>
              <a:xfrm rot="18928083">
                <a:off x="418798" y="6464565"/>
                <a:ext cx="679576" cy="2046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730" dirty="0" smtClean="0">
                    <a:latin typeface="Arial" pitchFamily="34" charset="0"/>
                    <a:cs typeface="Arial" pitchFamily="34" charset="0"/>
                  </a:rPr>
                  <a:t>n=89</a:t>
                </a:r>
                <a:endParaRPr lang="de-DE" sz="73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" name="Textfeld 107"/>
              <p:cNvSpPr txBox="1"/>
              <p:nvPr/>
            </p:nvSpPr>
            <p:spPr>
              <a:xfrm rot="18928083">
                <a:off x="-39755" y="6122297"/>
                <a:ext cx="2045009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730" dirty="0" smtClean="0">
                    <a:latin typeface="Arial" pitchFamily="34" charset="0"/>
                    <a:cs typeface="Arial" pitchFamily="34" charset="0"/>
                  </a:rPr>
                  <a:t>5q-, RA, RARS, RCMD, RSCMD</a:t>
                </a:r>
                <a:endParaRPr lang="de-DE" sz="73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" name="Textfeld 104"/>
              <p:cNvSpPr txBox="1"/>
              <p:nvPr/>
            </p:nvSpPr>
            <p:spPr>
              <a:xfrm rot="18928083">
                <a:off x="1285291" y="6025214"/>
                <a:ext cx="679576" cy="2046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730" dirty="0" smtClean="0">
                    <a:latin typeface="Arial" pitchFamily="34" charset="0"/>
                    <a:cs typeface="Arial" pitchFamily="34" charset="0"/>
                  </a:rPr>
                  <a:t>n=28</a:t>
                </a:r>
                <a:endParaRPr lang="de-DE" sz="73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" name="Textfeld 105"/>
              <p:cNvSpPr txBox="1"/>
              <p:nvPr/>
            </p:nvSpPr>
            <p:spPr>
              <a:xfrm rot="18928083">
                <a:off x="826738" y="5674995"/>
                <a:ext cx="2045009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730" dirty="0" smtClean="0">
                    <a:latin typeface="Arial" pitchFamily="34" charset="0"/>
                    <a:cs typeface="Arial" pitchFamily="34" charset="0"/>
                  </a:rPr>
                  <a:t>RAEB1, CMML1</a:t>
                </a:r>
                <a:endParaRPr lang="de-DE" sz="73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" name="Textfeld 102"/>
              <p:cNvSpPr txBox="1"/>
              <p:nvPr/>
            </p:nvSpPr>
            <p:spPr>
              <a:xfrm rot="18928083">
                <a:off x="1737850" y="6020680"/>
                <a:ext cx="679576" cy="2046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730" dirty="0" smtClean="0">
                    <a:latin typeface="Arial" pitchFamily="34" charset="0"/>
                    <a:cs typeface="Arial" pitchFamily="34" charset="0"/>
                  </a:rPr>
                  <a:t>n=30</a:t>
                </a:r>
                <a:endParaRPr lang="de-DE" sz="73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" name="Textfeld 103"/>
              <p:cNvSpPr txBox="1"/>
              <p:nvPr/>
            </p:nvSpPr>
            <p:spPr>
              <a:xfrm rot="18928083">
                <a:off x="1994944" y="6169409"/>
                <a:ext cx="679576" cy="2046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730" dirty="0" smtClean="0">
                    <a:latin typeface="Arial" pitchFamily="34" charset="0"/>
                    <a:cs typeface="Arial" pitchFamily="34" charset="0"/>
                  </a:rPr>
                  <a:t>n=9</a:t>
                </a:r>
                <a:endParaRPr lang="de-DE" sz="73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0" name="Textfeld 99"/>
              <p:cNvSpPr txBox="1"/>
              <p:nvPr/>
            </p:nvSpPr>
            <p:spPr>
              <a:xfrm rot="18928083">
                <a:off x="1536391" y="5803288"/>
                <a:ext cx="2045009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730" dirty="0" err="1" smtClean="0">
                    <a:latin typeface="Arial" pitchFamily="34" charset="0"/>
                    <a:cs typeface="Arial" pitchFamily="34" charset="0"/>
                  </a:rPr>
                  <a:t>Healthy</a:t>
                </a:r>
                <a:r>
                  <a:rPr lang="de-DE" sz="730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de-DE" sz="730" dirty="0" err="1" smtClean="0">
                    <a:latin typeface="Arial" pitchFamily="34" charset="0"/>
                    <a:cs typeface="Arial" pitchFamily="34" charset="0"/>
                  </a:rPr>
                  <a:t>Granulocytes</a:t>
                </a:r>
                <a:endParaRPr lang="de-DE" sz="73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11" name="Rechteck 10"/>
          <p:cNvSpPr/>
          <p:nvPr/>
        </p:nvSpPr>
        <p:spPr>
          <a:xfrm>
            <a:off x="419101" y="6812340"/>
            <a:ext cx="6210299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 smtClean="0">
                <a:latin typeface="Arial" pitchFamily="34" charset="0"/>
                <a:cs typeface="Arial" pitchFamily="34" charset="0"/>
              </a:rPr>
              <a:t>DNA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methylation levels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in WHO groups (5q-, deletion of chromosome 5q; RA, refractory anemia; RARS, refractory anemia with ringed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sideroblasts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; RCMD, refractory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cytopenia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with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multilineage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dysplasia; RCMD-RS, refractory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cytopenia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with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multilineade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dysplasia and ringed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sideroblasts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; RAEB, refractory anemia with excess of blasts; CMML, chronic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myelo-monocytic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leukemia) or IPSS classification risk groups (low, Int1, Int2, high) compared to </a:t>
            </a:r>
            <a:r>
              <a:rPr lang="en-US" sz="1200" smtClean="0">
                <a:latin typeface="Arial" pitchFamily="34" charset="0"/>
                <a:cs typeface="Arial" pitchFamily="34" charset="0"/>
              </a:rPr>
              <a:t>those in healthy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granulocytes are shown. Mann-Whitney U test was used to test for differences between the risk groups/WHO classification groups and healthy granulocytes (* p &lt; 0.05, ** p &lt; 0.01, *** p ≤ 0.001).</a:t>
            </a:r>
            <a:endParaRPr lang="de-DE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4132118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4</Words>
  <Application>Microsoft Office PowerPoint</Application>
  <PresentationFormat>Bildschirmpräsentation (4:3)</PresentationFormat>
  <Paragraphs>39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DKFZ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onnet</dc:creator>
  <cp:lastModifiedBy>sonnet</cp:lastModifiedBy>
  <cp:revision>22</cp:revision>
  <dcterms:created xsi:type="dcterms:W3CDTF">2012-04-24T17:36:27Z</dcterms:created>
  <dcterms:modified xsi:type="dcterms:W3CDTF">2013-12-15T14:09:16Z</dcterms:modified>
</cp:coreProperties>
</file>